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14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916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417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8344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2625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149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658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286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09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9546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1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31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47FCD-7748-474A-B1EB-40608E5F9873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A964F-1995-44CA-8196-13B8DD3B07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0498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E8FF0043-E617-2081-3D7F-247D46BFA17F}"/>
              </a:ext>
            </a:extLst>
          </p:cNvPr>
          <p:cNvGrpSpPr/>
          <p:nvPr/>
        </p:nvGrpSpPr>
        <p:grpSpPr>
          <a:xfrm>
            <a:off x="2554208" y="1186961"/>
            <a:ext cx="3433355" cy="2629356"/>
            <a:chOff x="2149761" y="896815"/>
            <a:chExt cx="3433355" cy="262935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D7E35A45-FA7C-6EFC-3578-18F26FE409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9761" y="896815"/>
              <a:ext cx="3433355" cy="2629356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888A1E9B-B6A3-EE7E-B876-085B45E504AA}"/>
                </a:ext>
              </a:extLst>
            </p:cNvPr>
            <p:cNvSpPr txBox="1"/>
            <p:nvPr/>
          </p:nvSpPr>
          <p:spPr>
            <a:xfrm>
              <a:off x="3031113" y="3293143"/>
              <a:ext cx="16706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insenoside Rg1 content (mg/g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F8801B7-88A8-AE69-72B5-B15F23C92F59}"/>
                </a:ext>
              </a:extLst>
            </p:cNvPr>
            <p:cNvSpPr txBox="1"/>
            <p:nvPr/>
          </p:nvSpPr>
          <p:spPr>
            <a:xfrm rot="16200000">
              <a:off x="1653652" y="2103771"/>
              <a:ext cx="14622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umber of ginseng cultivars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E2106750-7754-BB72-02DA-EF5C82ED9289}"/>
              </a:ext>
            </a:extLst>
          </p:cNvPr>
          <p:cNvSpPr txBox="1"/>
          <p:nvPr/>
        </p:nvSpPr>
        <p:spPr>
          <a:xfrm>
            <a:off x="1927734" y="3977381"/>
            <a:ext cx="4686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Rg1 content BLUP in four-year-old ginseng plant roots among 344 cultivars in a ginseng core collection representing the genetic variation and diversity of Jilin ginseng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9520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</TotalTime>
  <Words>4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6</cp:revision>
  <dcterms:created xsi:type="dcterms:W3CDTF">2024-03-28T07:47:34Z</dcterms:created>
  <dcterms:modified xsi:type="dcterms:W3CDTF">2024-07-10T09:21:09Z</dcterms:modified>
</cp:coreProperties>
</file>